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3BFE8EE-2973-4E9E-B16E-67DE5080AECC}" v="1" dt="2024-11-14T09:14:39.4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38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daf Naqvi" userId="8f91277e-8741-4995-819e-50b4e5326a9f" providerId="ADAL" clId="{43BFE8EE-2973-4E9E-B16E-67DE5080AECC}"/>
    <pc:docChg chg="custSel addSld delSld modSld">
      <pc:chgData name="Sadaf Naqvi" userId="8f91277e-8741-4995-819e-50b4e5326a9f" providerId="ADAL" clId="{43BFE8EE-2973-4E9E-B16E-67DE5080AECC}" dt="2024-11-14T09:15:37.966" v="136" actId="1076"/>
      <pc:docMkLst>
        <pc:docMk/>
      </pc:docMkLst>
      <pc:sldChg chg="del">
        <pc:chgData name="Sadaf Naqvi" userId="8f91277e-8741-4995-819e-50b4e5326a9f" providerId="ADAL" clId="{43BFE8EE-2973-4E9E-B16E-67DE5080AECC}" dt="2024-11-06T12:49:54.748" v="0" actId="2696"/>
        <pc:sldMkLst>
          <pc:docMk/>
          <pc:sldMk cId="2828968604" sldId="257"/>
        </pc:sldMkLst>
      </pc:sldChg>
      <pc:sldChg chg="delSp modSp mod">
        <pc:chgData name="Sadaf Naqvi" userId="8f91277e-8741-4995-819e-50b4e5326a9f" providerId="ADAL" clId="{43BFE8EE-2973-4E9E-B16E-67DE5080AECC}" dt="2024-11-06T12:57:09.897" v="4" actId="14100"/>
        <pc:sldMkLst>
          <pc:docMk/>
          <pc:sldMk cId="2496051410" sldId="258"/>
        </pc:sldMkLst>
        <pc:spChg chg="del mod">
          <ac:chgData name="Sadaf Naqvi" userId="8f91277e-8741-4995-819e-50b4e5326a9f" providerId="ADAL" clId="{43BFE8EE-2973-4E9E-B16E-67DE5080AECC}" dt="2024-11-06T12:57:05.849" v="2" actId="478"/>
          <ac:spMkLst>
            <pc:docMk/>
            <pc:sldMk cId="2496051410" sldId="258"/>
            <ac:spMk id="2" creationId="{40F46B62-FE3B-A1FB-59B0-FAC0EFE5C2C6}"/>
          </ac:spMkLst>
        </pc:spChg>
        <pc:picChg chg="mod">
          <ac:chgData name="Sadaf Naqvi" userId="8f91277e-8741-4995-819e-50b4e5326a9f" providerId="ADAL" clId="{43BFE8EE-2973-4E9E-B16E-67DE5080AECC}" dt="2024-11-06T12:57:09.897" v="4" actId="14100"/>
          <ac:picMkLst>
            <pc:docMk/>
            <pc:sldMk cId="2496051410" sldId="258"/>
            <ac:picMk id="4" creationId="{9FF74736-7F07-DD02-ADEF-BE09F886B7D1}"/>
          </ac:picMkLst>
        </pc:picChg>
      </pc:sldChg>
      <pc:sldChg chg="addSp delSp modSp new mod">
        <pc:chgData name="Sadaf Naqvi" userId="8f91277e-8741-4995-819e-50b4e5326a9f" providerId="ADAL" clId="{43BFE8EE-2973-4E9E-B16E-67DE5080AECC}" dt="2024-11-14T09:15:37.966" v="136" actId="1076"/>
        <pc:sldMkLst>
          <pc:docMk/>
          <pc:sldMk cId="3332509734" sldId="259"/>
        </pc:sldMkLst>
        <pc:spChg chg="mod">
          <ac:chgData name="Sadaf Naqvi" userId="8f91277e-8741-4995-819e-50b4e5326a9f" providerId="ADAL" clId="{43BFE8EE-2973-4E9E-B16E-67DE5080AECC}" dt="2024-11-14T09:15:31.628" v="134" actId="20577"/>
          <ac:spMkLst>
            <pc:docMk/>
            <pc:sldMk cId="3332509734" sldId="259"/>
            <ac:spMk id="2" creationId="{1E3F56CB-FB7F-822F-3926-A97D984D150B}"/>
          </ac:spMkLst>
        </pc:spChg>
        <pc:spChg chg="del">
          <ac:chgData name="Sadaf Naqvi" userId="8f91277e-8741-4995-819e-50b4e5326a9f" providerId="ADAL" clId="{43BFE8EE-2973-4E9E-B16E-67DE5080AECC}" dt="2024-11-14T09:14:38.047" v="6" actId="478"/>
          <ac:spMkLst>
            <pc:docMk/>
            <pc:sldMk cId="3332509734" sldId="259"/>
            <ac:spMk id="3" creationId="{2ADAEE2C-05D0-7B09-0A9F-7DA88B22A334}"/>
          </ac:spMkLst>
        </pc:spChg>
        <pc:picChg chg="add mod">
          <ac:chgData name="Sadaf Naqvi" userId="8f91277e-8741-4995-819e-50b4e5326a9f" providerId="ADAL" clId="{43BFE8EE-2973-4E9E-B16E-67DE5080AECC}" dt="2024-11-14T09:15:37.966" v="136" actId="1076"/>
          <ac:picMkLst>
            <pc:docMk/>
            <pc:sldMk cId="3332509734" sldId="259"/>
            <ac:picMk id="4" creationId="{D9429FCF-A776-4DB6-58B7-5E58FFD3BF2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68C48D-A486-6E89-6C7A-DC833FB704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09A8B7-7800-1F97-2344-E131617DFD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366FD-B4DB-7EB3-69FA-70BDCA504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64FAAD-A448-519A-AC74-50CBFBD97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9D17C6-AFC6-52D8-5D09-37C200C8C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4230053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20367E-44C3-D1F7-62F1-54693037B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A70232-D37C-8C45-3A9C-D7D5350FCB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FFC4D-41FB-8A01-C48C-9E7AB1434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D29CD3-BA08-0FC5-BB65-2EF7CAEF8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00B12C-0D6F-5AC1-F8ED-37D2569C3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307044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D219A9-A91D-C7A5-6CBD-D0B41679C7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E5AA97-77DB-C15D-C0D5-957D75A955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BCB0CF-3EDD-7C6D-DEB6-7549EFB1D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8D1FB4-5087-A930-5B78-8BF082608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24C854-BD81-F980-759A-021C54D2D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417246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C1290-586E-2DDF-F1DA-C4EA47D6C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49588F-3FF8-65AA-A891-CCD573DF01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FCD04-BFDA-C0C3-43C4-94C469968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1D8EFA-A88B-96B4-FF06-8B64917C1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1DC422-253A-BB67-0AF2-1E99BEA21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924414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A28A11-838D-D2DD-55B4-6C63FA743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D0C543-2535-07EB-B2F0-3312E7BF01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B32F60-B38A-792B-5C0F-5D7DDFC8F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9901F2-3097-0969-8A91-238962959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00D6CD-716B-DDAE-9196-7A976DC3A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2007601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ACE48-9899-EED3-1FC4-4840D8326C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3CD23E-A8B0-A862-1CD6-9F19A2B644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BA0B39-F16D-D778-642D-3F7907FC26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30BB97-F3DD-F112-1284-8E370C5F0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E3B947-9CFA-9355-9938-83716C32E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094360-C2EE-15FC-9D07-C95C64E55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178834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09226A-3E98-6E2C-6076-76A840B382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3905A3-2FD2-E093-6C79-E6082BC952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AD6E32-8D3C-04CF-B236-F1EB000A8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6B2E07-3657-7CE3-071E-AE71849719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B4621F-129A-4765-2034-2AC1BC7AF7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77AA78-6B7C-05E0-DBD1-54C009C86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D5CBAC-CF07-E87F-EA51-5447FD63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04EC99-3FC4-2CCC-AB2C-480CF7ACC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738471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E9A408-574A-C2D3-DBE3-4FBB9E05F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93148F-C0CD-D23A-2717-216D09552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D63BCC-DBA8-D378-4D42-0F379F7DD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DE92133-D309-DEED-0999-67A24FC01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942059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E16AF3-921C-DF98-4624-AC09DE867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197E7C-B0F6-F9A3-8683-4A9337C17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450C66-C365-F829-171C-02C62AA33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981753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EDF864-A919-6F29-1BD7-5CFEB91D1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10DAE7-6B29-965F-37F8-149486260B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EABF2F-38E4-0EE4-9996-53BFE050E6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89D6B5-9D01-F30D-4159-55F9DBD59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ADFDA9-F64B-1FFD-789B-2C0A84362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1AE6F0-13C2-3050-C08A-0E61BCD8A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53463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F4C22-D012-ADED-149E-2EECDBE47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A5229D-5729-4C84-A459-AC2F81ADA9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9B3EC1-9AC3-71DC-3152-2C31E60DDF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37BE77-09DB-BE68-F16D-51E0EF033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159977-7F6B-276B-0522-F5E17DEF0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7D6283-0C91-BE41-CDC0-5822DEB60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821484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43B1B0-CD18-7AA8-63A5-F312D126B9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9DD10-F90E-FC0F-E0DE-6A4CB3E626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EA191F-B78C-5713-36C0-FC9FA45A58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28C02B-9201-A477-6705-D22C8BD4B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321A6F-A45E-93A5-4616-55CCBD971C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576806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9FF74736-7F07-DD02-ADEF-BE09F886B7D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532889" y="1947672"/>
            <a:ext cx="6428480" cy="3644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60514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3F56CB-FB7F-822F-3926-A97D984D15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Figure 4: Major predictors contributing to the No Show prediction AI model from PHC Visits data</a:t>
            </a:r>
            <a:endParaRPr lang="en-AE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D9429FCF-A776-4DB6-58B7-5E58FFD3BF2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840162" y="1855307"/>
            <a:ext cx="7599402" cy="43087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2509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</TotalTime>
  <Words>17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Figure 4: Major predictors contributing to the No Show prediction AI model from PHC Visits data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daf Naqvi</dc:creator>
  <cp:lastModifiedBy>Sadaf Naqvi</cp:lastModifiedBy>
  <cp:revision>2</cp:revision>
  <dcterms:created xsi:type="dcterms:W3CDTF">2024-11-06T09:04:20Z</dcterms:created>
  <dcterms:modified xsi:type="dcterms:W3CDTF">2024-11-14T09:15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3c76ce46-357f-46de-88d6-77b9bbb83c46_Enabled">
    <vt:lpwstr>true</vt:lpwstr>
  </property>
  <property fmtid="{D5CDD505-2E9C-101B-9397-08002B2CF9AE}" pid="3" name="MSIP_Label_3c76ce46-357f-46de-88d6-77b9bbb83c46_SetDate">
    <vt:lpwstr>2024-11-06T09:05:46Z</vt:lpwstr>
  </property>
  <property fmtid="{D5CDD505-2E9C-101B-9397-08002B2CF9AE}" pid="4" name="MSIP_Label_3c76ce46-357f-46de-88d6-77b9bbb83c46_Method">
    <vt:lpwstr>Privileged</vt:lpwstr>
  </property>
  <property fmtid="{D5CDD505-2E9C-101B-9397-08002B2CF9AE}" pid="5" name="MSIP_Label_3c76ce46-357f-46de-88d6-77b9bbb83c46_Name">
    <vt:lpwstr>Public</vt:lpwstr>
  </property>
  <property fmtid="{D5CDD505-2E9C-101B-9397-08002B2CF9AE}" pid="6" name="MSIP_Label_3c76ce46-357f-46de-88d6-77b9bbb83c46_SiteId">
    <vt:lpwstr>4e2c6054-71cb-48f1-bd6c-3a9705aca71b</vt:lpwstr>
  </property>
  <property fmtid="{D5CDD505-2E9C-101B-9397-08002B2CF9AE}" pid="7" name="MSIP_Label_3c76ce46-357f-46de-88d6-77b9bbb83c46_ActionId">
    <vt:lpwstr>6109e0eb-3837-46db-a36e-5089aca50507</vt:lpwstr>
  </property>
  <property fmtid="{D5CDD505-2E9C-101B-9397-08002B2CF9AE}" pid="8" name="MSIP_Label_3c76ce46-357f-46de-88d6-77b9bbb83c46_ContentBits">
    <vt:lpwstr>0</vt:lpwstr>
  </property>
</Properties>
</file>